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7" r:id="rId2"/>
    <p:sldId id="264" r:id="rId3"/>
  </p:sldIdLst>
  <p:sldSz cx="6858000" cy="9144000" type="letter"/>
  <p:notesSz cx="6858000" cy="9144000"/>
  <p:custDataLst>
    <p:tags r:id="rId5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77" autoAdjust="0"/>
    <p:restoredTop sz="96300" autoAdjust="0"/>
  </p:normalViewPr>
  <p:slideViewPr>
    <p:cSldViewPr snapToGrid="0">
      <p:cViewPr varScale="1">
        <p:scale>
          <a:sx n="45" d="100"/>
          <a:sy n="45" d="100"/>
        </p:scale>
        <p:origin x="1922" y="22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B6100-92F3-49FB-AFF5-9D506F702C1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0A2E98-F576-48A8-9026-12D18E925B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73476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1pPr>
    <a:lvl2pPr marL="457199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2pPr>
    <a:lvl3pPr marL="914397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3pPr>
    <a:lvl4pPr marL="1371599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4pPr>
    <a:lvl5pPr marL="1828798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5pPr>
    <a:lvl6pPr marL="2285996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6pPr>
    <a:lvl7pPr marL="2743195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7pPr>
    <a:lvl8pPr marL="3200394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8pPr>
    <a:lvl9pPr marL="3657595" algn="l" defTabSz="914397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2369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527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716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121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2761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529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6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3180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9808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83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126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EDE75-DB4B-4851-9D5E-A27BE83937FB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2E3AB8-611B-4254-B516-AE225D08C9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455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26C5C78-8ED4-5E9F-E2E9-160C82CE8F9B}"/>
              </a:ext>
            </a:extLst>
          </p:cNvPr>
          <p:cNvSpPr txBox="1"/>
          <p:nvPr/>
        </p:nvSpPr>
        <p:spPr>
          <a:xfrm>
            <a:off x="0" y="494061"/>
            <a:ext cx="6835930" cy="62478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TGGCGGTGGCAGAGTCGTCACAGAACACGACAACCATGAGTGGTCACGGCGACTCGGATCTCAACAATTTCCGTAGAAGGAAACCGAGTTCCTCCGTGA 1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TGG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GT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AG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AGAACA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CCAT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T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G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ACGGCGACT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T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ACA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T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GGA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TCCA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TCCGTGA 100</a:t>
            </a:r>
          </a:p>
          <a:p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           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TTGAACCTTCGTCGTCCGGTTTTACATCCACCAATGGCGTACCGGCGACTGGCCACGTGGCTGAGAATCGTGACCAGGATCGGGTAGGGGCTATGGAGAA 2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C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AG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A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G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CCACCA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CG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T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CCACGTGG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GA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CCAGGATC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TGGAGAA 2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CGCAACAGGATCGGTCAACTTAATTGGAAATGGTGGAGGCGTGGTTATCGGGAATGAAGAGAAACAGGTAGGGGAGACTGATATACGATTCACTTACCGG 3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GCAACCGGCTCTGTGAACC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CGTGG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TCG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GA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AGG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GACTG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TCA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A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G 3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CTTCGTTTCCGGCTCATCGGAGGGTGAGGGAGAGTCCTCTTAGCTCTGATGCAATCTTCAAACA----------------------------------- 4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T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GGGT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GAG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CTCT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T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AG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GC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ATCTTCAA</a:t>
            </a:r>
            <a:r>
              <a:rPr lang="en-GB" sz="800" b="0" u="sng" dirty="0">
                <a:solidFill>
                  <a:srgbClr val="000000"/>
                </a:solidFill>
                <a:latin typeface="Courier New" panose="02070309020205020404" pitchFamily="49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CA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atggctgt</a:t>
            </a:r>
            <a:r>
              <a:rPr lang="en-GB" sz="800" dirty="0"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ttg</a:t>
            </a:r>
            <a:r>
              <a:rPr lang="en-GB" sz="8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</a:t>
            </a:r>
            <a:r>
              <a:rPr lang="en-GB" sz="800" dirty="0"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ct</a:t>
            </a:r>
            <a:r>
              <a:rPr lang="en-GB" sz="8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ttctctgctgtctta 400</a:t>
            </a:r>
          </a:p>
          <a:p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									</a:t>
            </a:r>
            <a:r>
              <a:rPr lang="en-US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NGATYTG-motif</a:t>
            </a:r>
            <a:endParaRPr lang="en-GB" sz="800" b="0" dirty="0">
              <a:solidFill>
                <a:srgbClr val="FF0000"/>
              </a:solidFill>
              <a:highlight>
                <a:srgbClr val="00FF00"/>
              </a:highlight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solidFill>
                  <a:srgbClr val="000000"/>
                </a:solidFill>
                <a:latin typeface="Courier New" panose="02070309020205020404" pitchFamily="49" charset="0"/>
              </a:rPr>
              <a:t>---------------------------------------------------------------------------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GCCATGCGGGTTTATTCAACTTG 500</a:t>
            </a:r>
            <a:endParaRPr lang="en-GB" sz="800" b="1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ctagtccttggtgttt</a:t>
            </a:r>
            <a:r>
              <a:rPr lang="en-GB" sz="80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ttttt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a</a:t>
            </a:r>
            <a:r>
              <a:rPr lang="en-GB" sz="800" dirty="0"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acat</a:t>
            </a:r>
            <a:r>
              <a:rPr lang="en-GB" sz="800" dirty="0">
                <a:effectLst/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</a:t>
            </a:r>
            <a:r>
              <a:rPr lang="en-GB" sz="800" dirty="0"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aa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ttatactggcctattcatttctg</a:t>
            </a:r>
            <a:r>
              <a:rPr lang="en-GB" sz="8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aaat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gt</a:t>
            </a:r>
            <a:r>
              <a:rPr lang="en-GB" sz="800" dirty="0">
                <a:effectLst/>
                <a:highlight>
                  <a:srgbClr val="808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atct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ca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A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 500</a:t>
            </a:r>
            <a:endParaRPr lang="en-GB" sz="800" b="0" dirty="0">
              <a:solidFill>
                <a:srgbClr val="000000"/>
              </a:solidFill>
              <a:highlight>
                <a:srgbClr val="00FF00"/>
              </a:highlight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800" dirty="0">
                <a:solidFill>
                  <a:srgbClr val="000000"/>
                </a:solidFill>
                <a:latin typeface="Courier New" panose="02070309020205020404" pitchFamily="49" charset="0"/>
              </a:rPr>
              <a:t>		</a:t>
            </a:r>
            <a:r>
              <a:rPr lang="en-GB" sz="800" b="0" dirty="0">
                <a:solidFill>
                  <a:srgbClr val="FF0000"/>
                </a:solidFill>
                <a:latin typeface="Courier New" panose="02070309020205020404" pitchFamily="49" charset="0"/>
              </a:rPr>
              <a:t>GT1-consensus</a:t>
            </a:r>
            <a:r>
              <a:rPr lang="en-GB" sz="800" dirty="0">
                <a:solidFill>
                  <a:srgbClr val="FF0000"/>
                </a:solidFill>
                <a:latin typeface="Courier New" panose="02070309020205020404" pitchFamily="49" charset="0"/>
              </a:rPr>
              <a:t> </a:t>
            </a:r>
            <a:r>
              <a:rPr lang="en-US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NGATYTG-motif </a:t>
            </a:r>
            <a:r>
              <a:rPr lang="en-GB" sz="800" b="0" dirty="0">
                <a:solidFill>
                  <a:srgbClr val="FF0000"/>
                </a:solidFill>
                <a:latin typeface="Courier New" panose="02070309020205020404" pitchFamily="49" charset="0"/>
              </a:rPr>
              <a:t>			</a:t>
            </a:r>
            <a:r>
              <a:rPr lang="en-GB" sz="800" dirty="0">
                <a:solidFill>
                  <a:srgbClr val="FF0000"/>
                </a:solidFill>
                <a:latin typeface="Courier New" panose="02070309020205020404" pitchFamily="49" charset="0"/>
              </a:rPr>
              <a:t> </a:t>
            </a:r>
            <a:r>
              <a:rPr lang="en-GB" sz="800" b="0" dirty="0">
                <a:solidFill>
                  <a:srgbClr val="FF0000"/>
                </a:solidFill>
                <a:latin typeface="Courier New" panose="02070309020205020404" pitchFamily="49" charset="0"/>
              </a:rPr>
              <a:t>CAAT-box NGATY-core</a:t>
            </a:r>
            <a:endParaRPr lang="en-GB" sz="800" dirty="0">
              <a:solidFill>
                <a:srgbClr val="000000"/>
              </a:solidFill>
              <a:highlight>
                <a:srgbClr val="00FF00"/>
              </a:highlight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TATAGTAGTGCTCATTGCAGTAAACAGTAGGCTTATCATCGAAAATCTTATGAAGTATGGTTGGTTGATCGATACTGGTTTCTGGTTTAGCTCAAGAT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6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CA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CATC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AAG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ATC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TGG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6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CTGGGTGATTGGTCCATCTTTATGTGCTGTCTTACACTCCCAATTTTCCCACTTGCTGCTTTTATTGTTGAAAAGCTGGTGCAGCGAAATCATATAT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7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TC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TGC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C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7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AACTTGTTGCTGTTCTCCTTCATGTAATCGTTTCTACCGCTGCAGTTTTATATCCAGTTATTGTGATCTTAACGTGTGATTCGGTGTATATGTCTGGT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8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C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C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G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8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TGGTATTGATGCTCTTTGGTTGCATTATGTGGTTGAAGCTGGTGTCATATGCACATACTAGTTCTGATATTAGAACACTGGCCAAATCTGGCTATAAG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9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G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ATGCTC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T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AAG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CC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GGCC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C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GB" sz="800" dirty="0">
                <a:solidFill>
                  <a:srgbClr val="000000"/>
                </a:solidFill>
                <a:latin typeface="Courier New" panose="02070309020205020404" pitchFamily="49" charset="0"/>
              </a:rPr>
              <a:t>9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GATGCGCACCCCAATTCAACCATTGTGAGTTGCTCATATGATGTTAGCTTGAAGAGTTTGGCATACTTCATGGTTGCTCCGACATTATGTTACCAGC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0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CCCC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AAGA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CTTCATG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CCAGC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GB" sz="800" dirty="0">
                <a:solidFill>
                  <a:srgbClr val="000000"/>
                </a:solidFill>
                <a:latin typeface="Courier New" panose="02070309020205020404" pitchFamily="49" charset="0"/>
              </a:rPr>
              <a:t>10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GCTATCCTCGTTCGTCGTGTATCCGCAAGGGTTGGGTTGTTCGTCAATTTGTCAAACTAATAGTTTTCATAGGACTCATGGGGTTCATTATAGAACA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1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CATG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1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TATTAATCCTATCGTTCGAAATTCCAAACACCCATTGAAAGGAGATTTTTTATATGCAATAGAAAGAGTTTTGAAGCTTTCAGTTCCAAATCTATAT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2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C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C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AAG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2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TGGCTTTGCATGTTCTACTCTTTTTTCCACCTCTGGTTGAACATACTGGCTGAGCTTCTTCGCTTTGGTGATCGTGAATTCTACAAAGATTGGTGGA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3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CATGTTCT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CAC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CATCCTC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G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TAC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TGGA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3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CAAAAACTGTTGCGGAGTATTGGAAAATGTGGAATATGCCTGTTCATAGATGGATGGTTCGTCATCTATATTTTCCCTGTTTGAGGAATGGGATACCC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4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G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TGG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ATG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4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GAAGGTGCCATTATTATCGCGTTCTTAGTTTCTGGTGCTTTCCATGAGCTCTGCATTGCAGTTCCTTGCCACGTATTCAAGTTATGGGCCTTTATA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5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GAA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C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GCTCTG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A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CCAC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TCAA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GCC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5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ATTATGTTTCAGGTTCCCTTGGTATTGATTACGAATTATCTACAAGAAAAGTTCAGTAATTCTATGGTGGGCAATATGATCTTCTGGTTCATCTTCT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600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T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G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TT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C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G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C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ATCTTCTGGTTCATCTTCTG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 1600</a:t>
            </a:r>
          </a:p>
          <a:p>
            <a:endParaRPr lang="en-GB" sz="800" b="0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) 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TACTTGGCCAACCTATGTGTGTCCTTCTATATTACCATGACCTGATAAATCTAAAGGAAAAGTG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					1667</a:t>
            </a:r>
          </a:p>
          <a:p>
            <a:r>
              <a:rPr lang="en-GB" sz="800" b="1" dirty="0">
                <a:solidFill>
                  <a:srgbClr val="000000"/>
                </a:solidFill>
                <a:latin typeface="Courier New" panose="02070309020205020404" pitchFamily="49" charset="0"/>
              </a:rPr>
              <a:t>(II) 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C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C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TGTG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ACC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ACCTGA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T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GA</a:t>
            </a:r>
            <a:r>
              <a:rPr lang="en-GB" sz="800" u="sng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GB" sz="8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AAGTGA</a:t>
            </a:r>
            <a:r>
              <a:rPr lang="en-GB" sz="800" b="0" dirty="0">
                <a:solidFill>
                  <a:srgbClr val="000000"/>
                </a:solidFill>
                <a:latin typeface="Courier New" panose="02070309020205020404" pitchFamily="49" charset="0"/>
              </a:rPr>
              <a:t>					1667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4B93213-6510-E8A0-ECE8-0D38A812AC45}"/>
              </a:ext>
            </a:extLst>
          </p:cNvPr>
          <p:cNvSpPr/>
          <p:nvPr/>
        </p:nvSpPr>
        <p:spPr>
          <a:xfrm>
            <a:off x="219575" y="7259191"/>
            <a:ext cx="6120000" cy="18596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Comparison of a native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GAT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 gene (I) from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opaeolum majus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an optimized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GAT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 gene (II). 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underlined letters indicate nucleotides that were modified for codon optimization. The lowercase letters indicate the inserted intron. The TTNGATYTG-like motif is highlighted in purple with nucleotides that deviated from the motif are marked in green. Extra nucleotide compared to the TTNGATYTG is highlighted in gray. The GT1-consensus, the CAAT box and the NGATY core of the longer TTNGATYTG motif are highlighted in blue, yellow, and dark yellow, respectively. </a:t>
            </a:r>
            <a:endParaRPr lang="en-GB" sz="1200" dirty="0">
              <a:solidFill>
                <a:srgbClr val="000000"/>
              </a:solidFill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42467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>
            <a:extLst>
              <a:ext uri="{FF2B5EF4-FFF2-40B4-BE49-F238E27FC236}">
                <a16:creationId xmlns:a16="http://schemas.microsoft.com/office/drawing/2014/main" id="{B9D90C16-2FCC-56AD-7F95-247614A208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1584" y="5340940"/>
            <a:ext cx="5432007" cy="106079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0147285-97B4-DBCF-03A6-E2CBF2B8D59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1101" y="4065195"/>
            <a:ext cx="5425910" cy="106079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3EED442A-BF0A-F105-2638-6064D98B072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5910" y="2755201"/>
            <a:ext cx="5444200" cy="106079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9A659F5-70DD-2D16-95D2-D2D13F7CAE1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1995" y="1468405"/>
            <a:ext cx="5450296" cy="106079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32A9433-D5DD-C60A-7D5A-1D50774392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1101" y="122295"/>
            <a:ext cx="5480779" cy="106079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EAD7E79-BA87-C996-700E-D682E8F9A533}"/>
              </a:ext>
            </a:extLst>
          </p:cNvPr>
          <p:cNvSpPr/>
          <p:nvPr/>
        </p:nvSpPr>
        <p:spPr>
          <a:xfrm>
            <a:off x="295559" y="6741287"/>
            <a:ext cx="6120000" cy="17103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PCR analysis of transgenic plants. A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PCR amplification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G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(W)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G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(In)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L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RI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 or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pt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rom genomic DNA of transgenic plants, respectively. PC. Positive control (plasmid used for transformation), Genomic DNA extracts of non-transgenic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ergycan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lant (WT) were used as the negative control. W: no intron. In: intron. Arrows indicate target amplicon.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ts val="2000"/>
              </a:lnSpc>
              <a:spcAft>
                <a:spcPts val="800"/>
              </a:spcAft>
            </a:pPr>
            <a:endParaRPr lang="en-GB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1A30A4C-FAD0-3094-1727-419DBE02EC99}"/>
              </a:ext>
            </a:extLst>
          </p:cNvPr>
          <p:cNvSpPr txBox="1"/>
          <p:nvPr/>
        </p:nvSpPr>
        <p:spPr>
          <a:xfrm>
            <a:off x="11734" y="12057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C3A440-5587-78C6-18CE-08655AE2BB64}"/>
              </a:ext>
            </a:extLst>
          </p:cNvPr>
          <p:cNvSpPr txBox="1"/>
          <p:nvPr/>
        </p:nvSpPr>
        <p:spPr>
          <a:xfrm>
            <a:off x="5254532" y="158883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F8DDB43-D069-C47F-1A60-D3ABCE60428B}"/>
              </a:ext>
            </a:extLst>
          </p:cNvPr>
          <p:cNvSpPr txBox="1"/>
          <p:nvPr/>
        </p:nvSpPr>
        <p:spPr>
          <a:xfrm>
            <a:off x="5528360" y="1588831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ECF7632-4FDC-797B-FA4D-C0F5154B890B}"/>
              </a:ext>
            </a:extLst>
          </p:cNvPr>
          <p:cNvSpPr txBox="1"/>
          <p:nvPr/>
        </p:nvSpPr>
        <p:spPr>
          <a:xfrm>
            <a:off x="11734" y="146607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621BCF2-4A0B-6CF0-D452-9F2FFCBE2271}"/>
              </a:ext>
            </a:extLst>
          </p:cNvPr>
          <p:cNvSpPr txBox="1"/>
          <p:nvPr/>
        </p:nvSpPr>
        <p:spPr>
          <a:xfrm>
            <a:off x="5287226" y="278574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43AADB0-243D-96FD-426D-94DD90EF1C67}"/>
              </a:ext>
            </a:extLst>
          </p:cNvPr>
          <p:cNvSpPr txBox="1"/>
          <p:nvPr/>
        </p:nvSpPr>
        <p:spPr>
          <a:xfrm>
            <a:off x="5561054" y="2785741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E9A1555-DA9E-98AD-69A4-626861D3F092}"/>
              </a:ext>
            </a:extLst>
          </p:cNvPr>
          <p:cNvSpPr txBox="1"/>
          <p:nvPr/>
        </p:nvSpPr>
        <p:spPr>
          <a:xfrm>
            <a:off x="11734" y="275496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71EA525-EDF9-F0D8-C79E-1FA065BFED6E}"/>
              </a:ext>
            </a:extLst>
          </p:cNvPr>
          <p:cNvSpPr txBox="1"/>
          <p:nvPr/>
        </p:nvSpPr>
        <p:spPr>
          <a:xfrm>
            <a:off x="5275532" y="41490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D174287-CD6C-8E39-6960-C26500C0E523}"/>
              </a:ext>
            </a:extLst>
          </p:cNvPr>
          <p:cNvSpPr txBox="1"/>
          <p:nvPr/>
        </p:nvSpPr>
        <p:spPr>
          <a:xfrm>
            <a:off x="5536660" y="4149052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8D22687-8CBC-458C-BA18-45E0B609BA45}"/>
              </a:ext>
            </a:extLst>
          </p:cNvPr>
          <p:cNvSpPr txBox="1"/>
          <p:nvPr/>
        </p:nvSpPr>
        <p:spPr>
          <a:xfrm>
            <a:off x="11734" y="404385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8174E42-3399-C1FA-5DA9-4C4676D8DF5E}"/>
              </a:ext>
            </a:extLst>
          </p:cNvPr>
          <p:cNvCxnSpPr>
            <a:cxnSpLocks/>
          </p:cNvCxnSpPr>
          <p:nvPr/>
        </p:nvCxnSpPr>
        <p:spPr>
          <a:xfrm flipH="1">
            <a:off x="5880110" y="1839169"/>
            <a:ext cx="20057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6FCD446E-DF46-7B4F-2D03-E6269975666C}"/>
              </a:ext>
            </a:extLst>
          </p:cNvPr>
          <p:cNvCxnSpPr>
            <a:cxnSpLocks/>
          </p:cNvCxnSpPr>
          <p:nvPr/>
        </p:nvCxnSpPr>
        <p:spPr>
          <a:xfrm flipH="1">
            <a:off x="5880110" y="3089338"/>
            <a:ext cx="20057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9F499398-413A-7733-1771-46606AC848B7}"/>
              </a:ext>
            </a:extLst>
          </p:cNvPr>
          <p:cNvCxnSpPr>
            <a:cxnSpLocks/>
          </p:cNvCxnSpPr>
          <p:nvPr/>
        </p:nvCxnSpPr>
        <p:spPr>
          <a:xfrm flipH="1">
            <a:off x="5880110" y="4507294"/>
            <a:ext cx="20057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BD88A70F-A906-4B9E-7991-B877A1B332DA}"/>
              </a:ext>
            </a:extLst>
          </p:cNvPr>
          <p:cNvCxnSpPr>
            <a:cxnSpLocks/>
          </p:cNvCxnSpPr>
          <p:nvPr/>
        </p:nvCxnSpPr>
        <p:spPr>
          <a:xfrm flipH="1">
            <a:off x="5880110" y="5945008"/>
            <a:ext cx="20057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24840DC-1781-79F9-3746-44D77F9E4A9E}"/>
              </a:ext>
            </a:extLst>
          </p:cNvPr>
          <p:cNvSpPr txBox="1"/>
          <p:nvPr/>
        </p:nvSpPr>
        <p:spPr>
          <a:xfrm>
            <a:off x="5222050" y="205466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706DFAC-1881-0A22-3914-D30E93B60104}"/>
              </a:ext>
            </a:extLst>
          </p:cNvPr>
          <p:cNvSpPr txBox="1"/>
          <p:nvPr/>
        </p:nvSpPr>
        <p:spPr>
          <a:xfrm>
            <a:off x="5536341" y="205466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4825D411-CEA1-E54A-C0F3-D974750410E2}"/>
              </a:ext>
            </a:extLst>
          </p:cNvPr>
          <p:cNvCxnSpPr>
            <a:cxnSpLocks/>
          </p:cNvCxnSpPr>
          <p:nvPr/>
        </p:nvCxnSpPr>
        <p:spPr>
          <a:xfrm flipH="1">
            <a:off x="5880110" y="577735"/>
            <a:ext cx="20057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FA07A81B-B757-898F-5969-DBB20CBC79E5}"/>
              </a:ext>
            </a:extLst>
          </p:cNvPr>
          <p:cNvSpPr txBox="1"/>
          <p:nvPr/>
        </p:nvSpPr>
        <p:spPr>
          <a:xfrm>
            <a:off x="11734" y="533275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EC57F4-5A99-30E5-0129-FF9A5A958F77}"/>
              </a:ext>
            </a:extLst>
          </p:cNvPr>
          <p:cNvSpPr txBox="1"/>
          <p:nvPr/>
        </p:nvSpPr>
        <p:spPr>
          <a:xfrm>
            <a:off x="5203732" y="55566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E1C982A-23BB-55F1-3299-459F53641108}"/>
              </a:ext>
            </a:extLst>
          </p:cNvPr>
          <p:cNvSpPr txBox="1"/>
          <p:nvPr/>
        </p:nvSpPr>
        <p:spPr>
          <a:xfrm>
            <a:off x="5528360" y="5556652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2C087A-5F12-6334-9C63-C7EB3279D596}"/>
              </a:ext>
            </a:extLst>
          </p:cNvPr>
          <p:cNvSpPr txBox="1"/>
          <p:nvPr/>
        </p:nvSpPr>
        <p:spPr>
          <a:xfrm>
            <a:off x="6017186" y="439235"/>
            <a:ext cx="8899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AT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(W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302986A-FDFB-7F3B-8C33-FDD81203C316}"/>
              </a:ext>
            </a:extLst>
          </p:cNvPr>
          <p:cNvSpPr txBox="1"/>
          <p:nvPr/>
        </p:nvSpPr>
        <p:spPr>
          <a:xfrm>
            <a:off x="6017186" y="1709274"/>
            <a:ext cx="881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AT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(In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F95585E-0EF1-D72A-BDBB-CA868C8158C8}"/>
              </a:ext>
            </a:extLst>
          </p:cNvPr>
          <p:cNvSpPr txBox="1"/>
          <p:nvPr/>
        </p:nvSpPr>
        <p:spPr>
          <a:xfrm>
            <a:off x="6017185" y="2955241"/>
            <a:ext cx="5533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E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AA56F07-7509-DBB9-C245-D175A9DBF57D}"/>
              </a:ext>
            </a:extLst>
          </p:cNvPr>
          <p:cNvSpPr txBox="1"/>
          <p:nvPr/>
        </p:nvSpPr>
        <p:spPr>
          <a:xfrm>
            <a:off x="6017185" y="4374118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RI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5E3040C-7D8A-A938-01B5-8C172C31A6F9}"/>
              </a:ext>
            </a:extLst>
          </p:cNvPr>
          <p:cNvSpPr txBox="1"/>
          <p:nvPr/>
        </p:nvSpPr>
        <p:spPr>
          <a:xfrm>
            <a:off x="6017185" y="5767266"/>
            <a:ext cx="4812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pt</a:t>
            </a:r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5C3E6F2-B23B-3DA0-04D5-426436E73FEB}"/>
              </a:ext>
            </a:extLst>
          </p:cNvPr>
          <p:cNvSpPr txBox="1"/>
          <p:nvPr/>
        </p:nvSpPr>
        <p:spPr>
          <a:xfrm>
            <a:off x="741767" y="20546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C313AE0-9347-53A9-551D-F9CA187D4954}"/>
              </a:ext>
            </a:extLst>
          </p:cNvPr>
          <p:cNvSpPr txBox="1"/>
          <p:nvPr/>
        </p:nvSpPr>
        <p:spPr>
          <a:xfrm>
            <a:off x="1007615" y="20546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289BC7B-ED6F-17B0-FE76-57EA1D56071E}"/>
              </a:ext>
            </a:extLst>
          </p:cNvPr>
          <p:cNvSpPr txBox="1"/>
          <p:nvPr/>
        </p:nvSpPr>
        <p:spPr>
          <a:xfrm>
            <a:off x="1263175" y="20546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6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5A8E6D6-1A84-4509-3FDD-F5E36C982663}"/>
              </a:ext>
            </a:extLst>
          </p:cNvPr>
          <p:cNvSpPr txBox="1"/>
          <p:nvPr/>
        </p:nvSpPr>
        <p:spPr>
          <a:xfrm>
            <a:off x="1554915" y="20546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7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B39BF04-55CF-7793-A98B-7E5B890B8A60}"/>
              </a:ext>
            </a:extLst>
          </p:cNvPr>
          <p:cNvSpPr txBox="1"/>
          <p:nvPr/>
        </p:nvSpPr>
        <p:spPr>
          <a:xfrm>
            <a:off x="1820225" y="20546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0ABD5D9-06D7-8C28-E9E3-6F53CCA4CB10}"/>
              </a:ext>
            </a:extLst>
          </p:cNvPr>
          <p:cNvSpPr txBox="1"/>
          <p:nvPr/>
        </p:nvSpPr>
        <p:spPr>
          <a:xfrm>
            <a:off x="1019605" y="158883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9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F13881F-5A41-0226-13B0-9E73B1B0E84F}"/>
              </a:ext>
            </a:extLst>
          </p:cNvPr>
          <p:cNvSpPr txBox="1"/>
          <p:nvPr/>
        </p:nvSpPr>
        <p:spPr>
          <a:xfrm>
            <a:off x="1270984" y="158883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40D1B07-7093-5B2C-5345-E9F30B0BFB69}"/>
              </a:ext>
            </a:extLst>
          </p:cNvPr>
          <p:cNvSpPr txBox="1"/>
          <p:nvPr/>
        </p:nvSpPr>
        <p:spPr>
          <a:xfrm>
            <a:off x="1516526" y="158883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9102B6D-66F0-EB83-D2B9-F547B509550E}"/>
              </a:ext>
            </a:extLst>
          </p:cNvPr>
          <p:cNvSpPr txBox="1"/>
          <p:nvPr/>
        </p:nvSpPr>
        <p:spPr>
          <a:xfrm>
            <a:off x="1822078" y="158883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9A9D48E-6000-F67B-23C9-E7390A10ECC5}"/>
              </a:ext>
            </a:extLst>
          </p:cNvPr>
          <p:cNvSpPr txBox="1"/>
          <p:nvPr/>
        </p:nvSpPr>
        <p:spPr>
          <a:xfrm>
            <a:off x="2070814" y="158883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3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3AA7C3A-44C8-ED08-A361-A43821E4D314}"/>
              </a:ext>
            </a:extLst>
          </p:cNvPr>
          <p:cNvSpPr txBox="1"/>
          <p:nvPr/>
        </p:nvSpPr>
        <p:spPr>
          <a:xfrm>
            <a:off x="1334914" y="27857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4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115363F5-04D6-7626-213E-8E01F44BDEA2}"/>
              </a:ext>
            </a:extLst>
          </p:cNvPr>
          <p:cNvSpPr txBox="1"/>
          <p:nvPr/>
        </p:nvSpPr>
        <p:spPr>
          <a:xfrm>
            <a:off x="1551933" y="27857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6796BB5-6B70-14B8-58E7-C24E013BB0A9}"/>
              </a:ext>
            </a:extLst>
          </p:cNvPr>
          <p:cNvSpPr txBox="1"/>
          <p:nvPr/>
        </p:nvSpPr>
        <p:spPr>
          <a:xfrm>
            <a:off x="1822078" y="27857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6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1EF4466B-161D-376B-50EE-1CD283BA8E79}"/>
              </a:ext>
            </a:extLst>
          </p:cNvPr>
          <p:cNvSpPr txBox="1"/>
          <p:nvPr/>
        </p:nvSpPr>
        <p:spPr>
          <a:xfrm>
            <a:off x="2112189" y="27857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7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E01329B-389F-BDAB-F00D-4352D115BC90}"/>
              </a:ext>
            </a:extLst>
          </p:cNvPr>
          <p:cNvSpPr txBox="1"/>
          <p:nvPr/>
        </p:nvSpPr>
        <p:spPr>
          <a:xfrm>
            <a:off x="2638064" y="27857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8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8505D6D-BB07-50A1-21D4-C497C861946D}"/>
              </a:ext>
            </a:extLst>
          </p:cNvPr>
          <p:cNvSpPr txBox="1"/>
          <p:nvPr/>
        </p:nvSpPr>
        <p:spPr>
          <a:xfrm>
            <a:off x="2902388" y="27857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9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54B58239-13A6-BA40-47EF-715C621D6FF1}"/>
              </a:ext>
            </a:extLst>
          </p:cNvPr>
          <p:cNvSpPr txBox="1"/>
          <p:nvPr/>
        </p:nvSpPr>
        <p:spPr>
          <a:xfrm>
            <a:off x="3143852" y="278574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0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E9DB83FE-1951-1586-71E0-2197677BB053}"/>
              </a:ext>
            </a:extLst>
          </p:cNvPr>
          <p:cNvSpPr txBox="1"/>
          <p:nvPr/>
        </p:nvSpPr>
        <p:spPr>
          <a:xfrm>
            <a:off x="3976098" y="278574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1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610C3677-7537-CE4F-71EA-BBC6D990EF27}"/>
              </a:ext>
            </a:extLst>
          </p:cNvPr>
          <p:cNvSpPr txBox="1"/>
          <p:nvPr/>
        </p:nvSpPr>
        <p:spPr>
          <a:xfrm>
            <a:off x="4241946" y="278574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2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17CA8C6C-6C0F-C592-B77A-3D33982EA585}"/>
              </a:ext>
            </a:extLst>
          </p:cNvPr>
          <p:cNvSpPr txBox="1"/>
          <p:nvPr/>
        </p:nvSpPr>
        <p:spPr>
          <a:xfrm>
            <a:off x="4507794" y="278574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3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DDE4664A-0CA9-1843-9721-3DBAFEE0C008}"/>
              </a:ext>
            </a:extLst>
          </p:cNvPr>
          <p:cNvSpPr txBox="1"/>
          <p:nvPr/>
        </p:nvSpPr>
        <p:spPr>
          <a:xfrm>
            <a:off x="765698" y="41490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4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6D894622-4DBE-D458-B2BA-B3D3B912B2AD}"/>
              </a:ext>
            </a:extLst>
          </p:cNvPr>
          <p:cNvSpPr txBox="1"/>
          <p:nvPr/>
        </p:nvSpPr>
        <p:spPr>
          <a:xfrm>
            <a:off x="1032308" y="41490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5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5C5B9989-1FE2-FF02-F09F-9F72B18C9B65}"/>
              </a:ext>
            </a:extLst>
          </p:cNvPr>
          <p:cNvSpPr txBox="1"/>
          <p:nvPr/>
        </p:nvSpPr>
        <p:spPr>
          <a:xfrm>
            <a:off x="1298918" y="41490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6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E8FB5815-57AF-5F9B-12A4-E4BCEAA13164}"/>
              </a:ext>
            </a:extLst>
          </p:cNvPr>
          <p:cNvSpPr txBox="1"/>
          <p:nvPr/>
        </p:nvSpPr>
        <p:spPr>
          <a:xfrm>
            <a:off x="1565528" y="41490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7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8EA29374-82F3-4C6D-11F5-5395EBEB56F0}"/>
              </a:ext>
            </a:extLst>
          </p:cNvPr>
          <p:cNvSpPr txBox="1"/>
          <p:nvPr/>
        </p:nvSpPr>
        <p:spPr>
          <a:xfrm>
            <a:off x="1832138" y="41490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8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E4911BE7-A491-A576-3901-6B3650D413BF}"/>
              </a:ext>
            </a:extLst>
          </p:cNvPr>
          <p:cNvSpPr txBox="1"/>
          <p:nvPr/>
        </p:nvSpPr>
        <p:spPr>
          <a:xfrm>
            <a:off x="2098748" y="41490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9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F523BA21-8C58-937C-08B4-9B4E505D7071}"/>
              </a:ext>
            </a:extLst>
          </p:cNvPr>
          <p:cNvSpPr txBox="1"/>
          <p:nvPr/>
        </p:nvSpPr>
        <p:spPr>
          <a:xfrm>
            <a:off x="2346308" y="41490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0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D31E69AF-5F58-E331-588F-9C7E695506C5}"/>
              </a:ext>
            </a:extLst>
          </p:cNvPr>
          <p:cNvSpPr txBox="1"/>
          <p:nvPr/>
        </p:nvSpPr>
        <p:spPr>
          <a:xfrm>
            <a:off x="2612156" y="41490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1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AC88605E-6AF5-27C0-01A5-27B39DDB9285}"/>
              </a:ext>
            </a:extLst>
          </p:cNvPr>
          <p:cNvSpPr txBox="1"/>
          <p:nvPr/>
        </p:nvSpPr>
        <p:spPr>
          <a:xfrm>
            <a:off x="2878004" y="41490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2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3D87DB2F-2736-294D-854C-631060A10507}"/>
              </a:ext>
            </a:extLst>
          </p:cNvPr>
          <p:cNvSpPr txBox="1"/>
          <p:nvPr/>
        </p:nvSpPr>
        <p:spPr>
          <a:xfrm>
            <a:off x="3143852" y="41490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3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E5FA00E3-7478-3C49-23C1-A3F60258DF4D}"/>
              </a:ext>
            </a:extLst>
          </p:cNvPr>
          <p:cNvSpPr txBox="1"/>
          <p:nvPr/>
        </p:nvSpPr>
        <p:spPr>
          <a:xfrm>
            <a:off x="2307041" y="55566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4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F6191492-02B8-2B3E-D40C-7DB51A26B3D1}"/>
              </a:ext>
            </a:extLst>
          </p:cNvPr>
          <p:cNvSpPr txBox="1"/>
          <p:nvPr/>
        </p:nvSpPr>
        <p:spPr>
          <a:xfrm>
            <a:off x="2573651" y="55566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5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D9564256-A31F-AC12-9667-636056F6E0CD}"/>
              </a:ext>
            </a:extLst>
          </p:cNvPr>
          <p:cNvSpPr txBox="1"/>
          <p:nvPr/>
        </p:nvSpPr>
        <p:spPr>
          <a:xfrm>
            <a:off x="2840261" y="55566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6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70CB521E-5DE0-B43D-D91F-6B4A7920827B}"/>
              </a:ext>
            </a:extLst>
          </p:cNvPr>
          <p:cNvSpPr txBox="1"/>
          <p:nvPr/>
        </p:nvSpPr>
        <p:spPr>
          <a:xfrm>
            <a:off x="3106871" y="55566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7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55C73872-E5F6-8819-3A41-C4DAA754483B}"/>
              </a:ext>
            </a:extLst>
          </p:cNvPr>
          <p:cNvSpPr txBox="1"/>
          <p:nvPr/>
        </p:nvSpPr>
        <p:spPr>
          <a:xfrm>
            <a:off x="3373481" y="55566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8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DB93FBB3-95C6-31E9-4EDA-EB57A5329F5D}"/>
              </a:ext>
            </a:extLst>
          </p:cNvPr>
          <p:cNvSpPr txBox="1"/>
          <p:nvPr/>
        </p:nvSpPr>
        <p:spPr>
          <a:xfrm>
            <a:off x="3640091" y="55566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9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2FEC2D24-7FD7-8A93-DB03-35F3E4DA6307}"/>
              </a:ext>
            </a:extLst>
          </p:cNvPr>
          <p:cNvSpPr txBox="1"/>
          <p:nvPr/>
        </p:nvSpPr>
        <p:spPr>
          <a:xfrm>
            <a:off x="3887651" y="55566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0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BE576AA5-A70B-119C-411D-9A6166A8A2F6}"/>
              </a:ext>
            </a:extLst>
          </p:cNvPr>
          <p:cNvSpPr txBox="1"/>
          <p:nvPr/>
        </p:nvSpPr>
        <p:spPr>
          <a:xfrm>
            <a:off x="4153499" y="55566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1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B9FEDBAD-D706-12E6-683A-F1B608688C90}"/>
              </a:ext>
            </a:extLst>
          </p:cNvPr>
          <p:cNvSpPr txBox="1"/>
          <p:nvPr/>
        </p:nvSpPr>
        <p:spPr>
          <a:xfrm>
            <a:off x="4419347" y="55566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2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16991100-93AD-24D4-483F-C3BB6E83F592}"/>
              </a:ext>
            </a:extLst>
          </p:cNvPr>
          <p:cNvSpPr txBox="1"/>
          <p:nvPr/>
        </p:nvSpPr>
        <p:spPr>
          <a:xfrm>
            <a:off x="4685195" y="5556652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3</a:t>
            </a:r>
          </a:p>
        </p:txBody>
      </p:sp>
    </p:spTree>
    <p:extLst>
      <p:ext uri="{BB962C8B-B14F-4D97-AF65-F5344CB8AC3E}">
        <p14:creationId xmlns:p14="http://schemas.microsoft.com/office/powerpoint/2010/main" val="377275545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PROJECT_OPEN" val="0"/>
  <p:tag name="ARTICULATE_SLIDE_COUNT" val="4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93</TotalTime>
  <Words>462</Words>
  <Application>Microsoft Office PowerPoint</Application>
  <PresentationFormat>Letter Paper (8.5x11 in)</PresentationFormat>
  <Paragraphs>1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</vt:vector>
  </TitlesOfParts>
  <Company>SUND - K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angbin Luo</dc:creator>
  <cp:lastModifiedBy>Altpeter,Fredy</cp:lastModifiedBy>
  <cp:revision>66</cp:revision>
  <dcterms:created xsi:type="dcterms:W3CDTF">2022-04-12T08:29:58Z</dcterms:created>
  <dcterms:modified xsi:type="dcterms:W3CDTF">2023-08-30T08:45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rticulateGUID">
    <vt:lpwstr>CBAC49AF-8524-41DA-B714-6048DCA1F5B3</vt:lpwstr>
  </property>
  <property fmtid="{D5CDD505-2E9C-101B-9397-08002B2CF9AE}" pid="3" name="ArticulatePath">
    <vt:lpwstr>Figures_GL_150422</vt:lpwstr>
  </property>
</Properties>
</file>